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6" d="100"/>
          <a:sy n="166" d="100"/>
        </p:scale>
        <p:origin x="-438" y="22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90791776027996"/>
          <c:y val="5.4189997083697872E-2"/>
          <c:w val="0.70392760279965005"/>
          <c:h val="0.820099883347914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38</c:f>
              <c:strCache>
                <c:ptCount val="1"/>
                <c:pt idx="0">
                  <c:v>Water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L$39:$L$41</c:f>
                <c:numCache>
                  <c:formatCode>General</c:formatCode>
                  <c:ptCount val="3"/>
                  <c:pt idx="0">
                    <c:v>0.14161119999999999</c:v>
                  </c:pt>
                  <c:pt idx="1">
                    <c:v>0.11262107404556576</c:v>
                  </c:pt>
                  <c:pt idx="2">
                    <c:v>4.61946999999999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H$39:$H$41</c:f>
              <c:strCache>
                <c:ptCount val="3"/>
                <c:pt idx="0">
                  <c:v>Elovl3</c:v>
                </c:pt>
                <c:pt idx="1">
                  <c:v>G6pc</c:v>
                </c:pt>
                <c:pt idx="2">
                  <c:v>Pecr</c:v>
                </c:pt>
              </c:strCache>
            </c:strRef>
          </c:cat>
          <c:val>
            <c:numRef>
              <c:f>Sheet1!$I$39:$I$41</c:f>
              <c:numCache>
                <c:formatCode>General</c:formatCode>
                <c:ptCount val="3"/>
                <c:pt idx="0">
                  <c:v>0.97522109999999995</c:v>
                </c:pt>
                <c:pt idx="1">
                  <c:v>1.1279772857142858</c:v>
                </c:pt>
                <c:pt idx="2">
                  <c:v>1.1532197</c:v>
                </c:pt>
              </c:numCache>
            </c:numRef>
          </c:val>
        </c:ser>
        <c:ser>
          <c:idx val="1"/>
          <c:order val="1"/>
          <c:tx>
            <c:strRef>
              <c:f>Sheet1!$J$38</c:f>
              <c:strCache>
                <c:ptCount val="1"/>
                <c:pt idx="0">
                  <c:v>VAA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M$39:$M$41</c:f>
                <c:numCache>
                  <c:formatCode>General</c:formatCode>
                  <c:ptCount val="3"/>
                  <c:pt idx="0">
                    <c:v>9.2938300000000001E-2</c:v>
                  </c:pt>
                  <c:pt idx="1">
                    <c:v>0.1866865802124375</c:v>
                  </c:pt>
                  <c:pt idx="2">
                    <c:v>5.46779000000000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H$39:$H$41</c:f>
              <c:strCache>
                <c:ptCount val="3"/>
                <c:pt idx="0">
                  <c:v>Elovl3</c:v>
                </c:pt>
                <c:pt idx="1">
                  <c:v>G6pc</c:v>
                </c:pt>
                <c:pt idx="2">
                  <c:v>Pecr</c:v>
                </c:pt>
              </c:strCache>
            </c:strRef>
          </c:cat>
          <c:val>
            <c:numRef>
              <c:f>Sheet1!$J$39:$J$41</c:f>
              <c:numCache>
                <c:formatCode>General</c:formatCode>
                <c:ptCount val="3"/>
                <c:pt idx="0">
                  <c:v>0.57182200000000005</c:v>
                </c:pt>
                <c:pt idx="1">
                  <c:v>1.7460982857142857</c:v>
                </c:pt>
                <c:pt idx="2">
                  <c:v>0.91370660000000004</c:v>
                </c:pt>
              </c:numCache>
            </c:numRef>
          </c:val>
        </c:ser>
        <c:ser>
          <c:idx val="2"/>
          <c:order val="2"/>
          <c:tx>
            <c:strRef>
              <c:f>Sheet1!$K$38</c:f>
              <c:strCache>
                <c:ptCount val="1"/>
                <c:pt idx="0">
                  <c:v>CAAM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N$39:$N$41</c:f>
                <c:numCache>
                  <c:formatCode>General</c:formatCode>
                  <c:ptCount val="3"/>
                  <c:pt idx="0">
                    <c:v>0.29386810000000002</c:v>
                  </c:pt>
                  <c:pt idx="1">
                    <c:v>0.30006857888332794</c:v>
                  </c:pt>
                  <c:pt idx="2">
                    <c:v>0.10512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H$39:$H$41</c:f>
              <c:strCache>
                <c:ptCount val="3"/>
                <c:pt idx="0">
                  <c:v>Elovl3</c:v>
                </c:pt>
                <c:pt idx="1">
                  <c:v>G6pc</c:v>
                </c:pt>
                <c:pt idx="2">
                  <c:v>Pecr</c:v>
                </c:pt>
              </c:strCache>
            </c:strRef>
          </c:cat>
          <c:val>
            <c:numRef>
              <c:f>Sheet1!$K$39:$K$41</c:f>
              <c:numCache>
                <c:formatCode>General</c:formatCode>
                <c:ptCount val="3"/>
                <c:pt idx="0">
                  <c:v>0.67498219999999998</c:v>
                </c:pt>
                <c:pt idx="1">
                  <c:v>1.3196114000000001</c:v>
                </c:pt>
                <c:pt idx="2">
                  <c:v>0.9536898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529728"/>
        <c:axId val="195556096"/>
      </c:barChart>
      <c:catAx>
        <c:axId val="195529728"/>
        <c:scaling>
          <c:orientation val="minMax"/>
        </c:scaling>
        <c:delete val="1"/>
        <c:axPos val="b"/>
        <c:majorTickMark val="out"/>
        <c:minorTickMark val="none"/>
        <c:tickLblPos val="nextTo"/>
        <c:crossAx val="195556096"/>
        <c:crosses val="autoZero"/>
        <c:auto val="1"/>
        <c:lblAlgn val="ctr"/>
        <c:lblOffset val="100"/>
        <c:noMultiLvlLbl val="0"/>
      </c:catAx>
      <c:valAx>
        <c:axId val="195556096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aseline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95529728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0"/>
        <c:txPr>
          <a:bodyPr/>
          <a:lstStyle/>
          <a:p>
            <a:pPr>
              <a:defRPr sz="1000" baseline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1"/>
        <c:txPr>
          <a:bodyPr/>
          <a:lstStyle/>
          <a:p>
            <a:pPr>
              <a:defRPr sz="1000" baseline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6461329833770777"/>
          <c:y val="3.9851498825804674E-2"/>
          <c:w val="0.14649781277340332"/>
          <c:h val="0.253630335681724"/>
        </c:manualLayout>
      </c:layout>
      <c:overlay val="0"/>
      <c:txPr>
        <a:bodyPr/>
        <a:lstStyle/>
        <a:p>
          <a:pPr>
            <a:defRPr sz="1000" baseline="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85587-0E1E-4409-879B-95DC3D9C3D5D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71672C-26F5-4C5B-8031-7B2841A7E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87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71672C-26F5-4C5B-8031-7B2841A7E9A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953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2709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4463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815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094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7088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140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277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880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3251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528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31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56FCA-2295-420B-A090-82EB4C122AAC}" type="datetimeFigureOut">
              <a:rPr kumimoji="1" lang="ja-JP" altLang="en-US" smtClean="0"/>
              <a:t>2016/5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0360C-7F10-495C-B57B-634AA5EC7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574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29"/>
          <p:cNvSpPr txBox="1"/>
          <p:nvPr/>
        </p:nvSpPr>
        <p:spPr>
          <a:xfrm>
            <a:off x="463559" y="8668987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1354631" y="2915816"/>
            <a:ext cx="4738665" cy="3004706"/>
            <a:chOff x="1138607" y="3404592"/>
            <a:chExt cx="4738665" cy="3004706"/>
          </a:xfrm>
        </p:grpSpPr>
        <p:graphicFrame>
          <p:nvGraphicFramePr>
            <p:cNvPr id="24" name="グラフ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40465436"/>
                </p:ext>
              </p:extLst>
            </p:nvPr>
          </p:nvGraphicFramePr>
          <p:xfrm>
            <a:off x="1305272" y="3404592"/>
            <a:ext cx="4572000" cy="289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0" name="テキスト ボックス 19"/>
            <p:cNvSpPr txBox="1"/>
            <p:nvPr/>
          </p:nvSpPr>
          <p:spPr>
            <a:xfrm>
              <a:off x="3168060" y="3737552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右大かっこ 21"/>
            <p:cNvSpPr/>
            <p:nvPr/>
          </p:nvSpPr>
          <p:spPr>
            <a:xfrm rot="16200000">
              <a:off x="3224536" y="3875837"/>
              <a:ext cx="126012" cy="242923"/>
            </a:xfrm>
            <a:prstGeom prst="rightBracket">
              <a:avLst>
                <a:gd name="adj" fmla="val 0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 rot="5400000" flipV="1">
              <a:off x="72514" y="4576334"/>
              <a:ext cx="24091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 level 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975113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218036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2459473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3056901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3299824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541261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118100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361023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602460" y="59234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右大かっこ 17"/>
            <p:cNvSpPr/>
            <p:nvPr/>
          </p:nvSpPr>
          <p:spPr>
            <a:xfrm rot="16200000">
              <a:off x="2157097" y="4592412"/>
              <a:ext cx="126012" cy="242923"/>
            </a:xfrm>
            <a:prstGeom prst="rightBracket">
              <a:avLst>
                <a:gd name="adj" fmla="val 0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2097101" y="4492353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4242429" y="4446130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右大かっこ 27"/>
            <p:cNvSpPr/>
            <p:nvPr/>
          </p:nvSpPr>
          <p:spPr>
            <a:xfrm rot="16200000">
              <a:off x="4298905" y="4584415"/>
              <a:ext cx="126012" cy="242923"/>
            </a:xfrm>
            <a:prstGeom prst="rightBracket">
              <a:avLst>
                <a:gd name="adj" fmla="val 0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1672053" y="5915706"/>
              <a:ext cx="3658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 =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2103007" y="6151929"/>
              <a:ext cx="489484" cy="2573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kumimoji="1" lang="en-US" altLang="ja-JP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lovl3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3205663" y="6151929"/>
              <a:ext cx="439791" cy="2573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kumimoji="1" lang="en-US" altLang="ja-JP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6pc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4296405" y="6151929"/>
              <a:ext cx="388495" cy="2573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kumimoji="1" lang="en-US" altLang="ja-JP" sz="12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ecr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85568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</TotalTime>
  <Words>24</Words>
  <Application>Microsoft Office PowerPoint</Application>
  <PresentationFormat>画面に合わせる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OZAKI</dc:creator>
  <cp:lastModifiedBy>SHINOZAKI</cp:lastModifiedBy>
  <cp:revision>8</cp:revision>
  <cp:lastPrinted>2016-05-25T00:47:26Z</cp:lastPrinted>
  <dcterms:created xsi:type="dcterms:W3CDTF">2016-05-22T23:45:12Z</dcterms:created>
  <dcterms:modified xsi:type="dcterms:W3CDTF">2016-05-25T00:53:25Z</dcterms:modified>
</cp:coreProperties>
</file>